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2" r:id="rId2"/>
  </p:sldIdLst>
  <p:sldSz cx="12192000" cy="6858000"/>
  <p:notesSz cx="6858000" cy="9144000"/>
  <p:defaultTextStyle>
    <a:defPPr>
      <a:defRPr lang="es-C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6327"/>
  </p:normalViewPr>
  <p:slideViewPr>
    <p:cSldViewPr snapToGrid="0">
      <p:cViewPr varScale="1">
        <p:scale>
          <a:sx n="102" d="100"/>
          <a:sy n="102" d="100"/>
        </p:scale>
        <p:origin x="192" y="6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CL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7AAE98-8E8E-BA47-81CD-38B010F2CD39}" type="datetimeFigureOut">
              <a:rPr lang="es-CL" smtClean="0"/>
              <a:t>26-08-22</a:t>
            </a:fld>
            <a:endParaRPr lang="es-CL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CL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C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50AC5B1-7D3C-1744-8AC0-30067B21C9E5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1734655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5" name="Google Shape;185;p6:notes"/>
          <p:cNvSpPr txBox="1">
            <a:spLocks noGrp="1"/>
          </p:cNvSpPr>
          <p:nvPr>
            <p:ph type="body" idx="1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186" name="Google Shape;186;p6:notes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7F90F9F-EB36-E7B5-8AF3-48BE28B4C42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2ED49BAC-42E8-581E-5EFC-05E0D82FB63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95CCF21-F684-6F83-61C3-86D1F8FD17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FDE18-234D-AF43-AA34-8E5A4DAA8523}" type="datetimeFigureOut">
              <a:rPr lang="es-CL" smtClean="0"/>
              <a:t>26-08-22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CDC153D-4872-3141-0C04-68DF3315E9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C1B3E1F5-8CF2-5D5C-5F5B-38B92877AD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A1B06-6CEA-A647-AFB6-CB9021CA7FB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4305309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D0E020D-458D-7622-0D60-79A0299DA0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AADD2098-9E45-84C2-64AD-913DF623350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08CA275-F2D6-1EBF-B4C1-5C77E3E406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FDE18-234D-AF43-AA34-8E5A4DAA8523}" type="datetimeFigureOut">
              <a:rPr lang="es-CL" smtClean="0"/>
              <a:t>26-08-22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674D5CA-CDF1-FCF4-D7B1-CCD4E8041C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13842D7-CAC3-1C81-C4C9-65443F9444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A1B06-6CEA-A647-AFB6-CB9021CA7FB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1128313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1EC4889C-72C0-46DF-E7EC-04B96311A90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47E0584B-8F5F-C81B-8980-E4C9BBB909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2327623-6FF0-3BCF-92EE-2FF17D5315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FDE18-234D-AF43-AA34-8E5A4DAA8523}" type="datetimeFigureOut">
              <a:rPr lang="es-CL" smtClean="0"/>
              <a:t>26-08-22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B0BFA4C-011C-9828-BEB8-22FEE4D0AA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F29D66B-D776-1D2D-A267-F9B36E7964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A1B06-6CEA-A647-AFB6-CB9021CA7FB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0356416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E9FD063-12D4-54A8-6D8D-3B2CCA94AA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6C7E8724-641A-5F9D-9729-EB6B1A919BB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8DCAD85-68EB-CF7A-6E7B-77B89AB3BF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FDE18-234D-AF43-AA34-8E5A4DAA8523}" type="datetimeFigureOut">
              <a:rPr lang="es-CL" smtClean="0"/>
              <a:t>26-08-22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23590A8-D6E7-DACE-3A00-D8711BD18C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1298F96-57CE-E461-9A2B-522664A7BA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A1B06-6CEA-A647-AFB6-CB9021CA7FB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3331494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7946463-53CC-F595-12CB-DEFEE021ED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1BB11881-BE8E-3099-6C0F-07EA6A28BA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7C608B5-2D3A-D21E-F7E4-8818F17C1D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FDE18-234D-AF43-AA34-8E5A4DAA8523}" type="datetimeFigureOut">
              <a:rPr lang="es-CL" smtClean="0"/>
              <a:t>26-08-22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FDB1E09-6E98-93A5-0493-1251EBFC97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39C3017-8B9F-CC57-86C8-C60E8AE1A3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A1B06-6CEA-A647-AFB6-CB9021CA7FB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6955059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F1F5229-A11D-A0BA-E976-F840CA3C19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79A6A5E6-0461-1F42-A8F4-39375457137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6BC2A7DA-69A8-0759-3BA9-9CB2278C73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0A3CAF2E-151F-0A1F-38DA-A6629FCA29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FDE18-234D-AF43-AA34-8E5A4DAA8523}" type="datetimeFigureOut">
              <a:rPr lang="es-CL" smtClean="0"/>
              <a:t>26-08-22</a:t>
            </a:fld>
            <a:endParaRPr lang="es-C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A9132F90-B568-1AA7-611E-C07F3C643D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43512C7F-7DE2-C73F-A4A5-EF6EDBF08F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A1B06-6CEA-A647-AFB6-CB9021CA7FB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6529203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E089304-0E8E-1324-82F6-C4951C2504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5E38326-5D2F-7B42-9A52-6A05383409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C81DA6D7-DEA6-FC19-A7D4-A917F4BE252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FA5187DE-051D-6EB0-5ADD-F8DDD3EF660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8D3BF210-25BB-6F19-3846-A7E93963BB4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E349D2EC-80E9-835C-34DA-04AD89BB8C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FDE18-234D-AF43-AA34-8E5A4DAA8523}" type="datetimeFigureOut">
              <a:rPr lang="es-CL" smtClean="0"/>
              <a:t>26-08-22</a:t>
            </a:fld>
            <a:endParaRPr lang="es-CL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5542167D-1622-7AD8-F12A-A915078954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F64FA789-A956-6E2F-C6AF-3B0F415C5F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A1B06-6CEA-A647-AFB6-CB9021CA7FB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1963509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34AE279-322D-48D7-9DF9-8C1E576F63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5EBAB0E7-257A-BDF4-F0BE-4503D2AF84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FDE18-234D-AF43-AA34-8E5A4DAA8523}" type="datetimeFigureOut">
              <a:rPr lang="es-CL" smtClean="0"/>
              <a:t>26-08-22</a:t>
            </a:fld>
            <a:endParaRPr lang="es-CL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249B6ACE-AC43-8885-FEC5-8BD74A2639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CAEB7751-51EE-6F41-D6F5-76821D9864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A1B06-6CEA-A647-AFB6-CB9021CA7FB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0404373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50027241-2DAA-1B0E-CAC2-7BF5BBA77E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FDE18-234D-AF43-AA34-8E5A4DAA8523}" type="datetimeFigureOut">
              <a:rPr lang="es-CL" smtClean="0"/>
              <a:t>26-08-22</a:t>
            </a:fld>
            <a:endParaRPr lang="es-CL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7E1F0D99-F516-116C-C407-2B9F65B4A3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980DDA6A-1406-FD7C-9E26-69D008BC87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A1B06-6CEA-A647-AFB6-CB9021CA7FB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8188735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AB59C05-1BAA-475A-DD30-45EFC898EF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0314D3EB-5BA9-23F3-C722-47A73A4938F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8A29BE38-55BA-3667-9F2F-FC0AD562B9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63C4D8BF-893B-6724-0519-CC4E994CDF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FDE18-234D-AF43-AA34-8E5A4DAA8523}" type="datetimeFigureOut">
              <a:rPr lang="es-CL" smtClean="0"/>
              <a:t>26-08-22</a:t>
            </a:fld>
            <a:endParaRPr lang="es-C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17FD289E-5217-5DC1-6A90-8D9A90A438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D0AAC5FF-15D6-2BD6-6EF5-45BE72C01D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A1B06-6CEA-A647-AFB6-CB9021CA7FB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7349603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2A328B9-E6ED-AE12-5346-7F671FC430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930D6C6B-F22B-0D1D-71BD-52A34DBB721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L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A8D8F2FA-CA31-FFA8-DD68-43768029A4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14E5F4E4-E82A-6BED-E41E-17B8E284F2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FDE18-234D-AF43-AA34-8E5A4DAA8523}" type="datetimeFigureOut">
              <a:rPr lang="es-CL" smtClean="0"/>
              <a:t>26-08-22</a:t>
            </a:fld>
            <a:endParaRPr lang="es-C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3C5DC370-C600-33C9-DBDB-A345AB6E8C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4A4E9FE6-CB29-25B9-E576-9137E064BD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A1B06-6CEA-A647-AFB6-CB9021CA7FB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5671119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659619E1-C045-11DE-486C-4C36513596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E1BB34AD-DFAB-1137-61D1-E2F933CFC7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DD8E05C-0618-129E-9610-334365704E1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2FDE18-234D-AF43-AA34-8E5A4DAA8523}" type="datetimeFigureOut">
              <a:rPr lang="es-CL" smtClean="0"/>
              <a:t>26-08-22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9FA258B-E952-8187-00D2-9C39642D23A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79CB9D6-D72F-84E4-8E02-8B557C9D4FF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FA1B06-6CEA-A647-AFB6-CB9021CA7FB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4226049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8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8" name="Google Shape;188;p6" descr="Un conjunto de letras negras en un fondo blanco&#10;&#10;Descripción generada automáticamente con confianza media"/>
          <p:cNvPicPr preferRelativeResize="0">
            <a:picLocks noGrp="1"/>
          </p:cNvPicPr>
          <p:nvPr>
            <p:ph type="body" idx="1"/>
          </p:nvPr>
        </p:nvPicPr>
        <p:blipFill rotWithShape="1">
          <a:blip r:embed="rId3">
            <a:alphaModFix/>
          </a:blip>
          <a:srcRect l="13726" r="11636"/>
          <a:stretch/>
        </p:blipFill>
        <p:spPr>
          <a:xfrm>
            <a:off x="585217" y="969264"/>
            <a:ext cx="5776920" cy="5418011"/>
          </a:xfrm>
          <a:prstGeom prst="rect">
            <a:avLst/>
          </a:prstGeom>
          <a:noFill/>
          <a:ln>
            <a:noFill/>
          </a:ln>
        </p:spPr>
      </p:pic>
      <p:sp>
        <p:nvSpPr>
          <p:cNvPr id="189" name="Google Shape;189;p6"/>
          <p:cNvSpPr txBox="1"/>
          <p:nvPr/>
        </p:nvSpPr>
        <p:spPr>
          <a:xfrm>
            <a:off x="4190566" y="5987534"/>
            <a:ext cx="2340863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es-CL" sz="12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Created with BioRender.com</a:t>
            </a:r>
            <a:endParaRPr sz="1200" b="0" i="0" u="none" strike="noStrike" cap="none">
              <a:solidFill>
                <a:schemeClr val="dk1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</p:txBody>
      </p:sp>
      <p:sp>
        <p:nvSpPr>
          <p:cNvPr id="190" name="Google Shape;190;p6"/>
          <p:cNvSpPr txBox="1"/>
          <p:nvPr/>
        </p:nvSpPr>
        <p:spPr>
          <a:xfrm>
            <a:off x="6531429" y="1068290"/>
            <a:ext cx="5146800" cy="18162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s-CL" sz="1400" b="1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UPPLEMENTARY FIGURE 1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: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Illustration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of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the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design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of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the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physiological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experiment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.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For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this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research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,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two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different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greenhouses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were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used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: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greenhouse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one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(GH1) and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greenhouse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two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(GH2). 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Eight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plants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from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each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genotype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were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inoculated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and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randomly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distributed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in GH1,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here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referred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to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as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inoculated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plants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. As a control,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another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group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of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eight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plants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of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each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genotype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was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eparated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in GH2,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here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referred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to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as non-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inoculated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plants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.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Plants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were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randomly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distributed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in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each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s-CL" sz="1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greenhouse</a:t>
            </a:r>
            <a:r>
              <a:rPr lang="es-CL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. </a:t>
            </a:r>
            <a:endParaRPr sz="1400" b="0" i="0" u="none" strike="noStrike" cap="none" dirty="0">
              <a:solidFill>
                <a:schemeClr val="dk1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1</Words>
  <Application>Microsoft Macintosh PowerPoint</Application>
  <PresentationFormat>Panorámica</PresentationFormat>
  <Paragraphs>2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amela zuñiga contreras</dc:creator>
  <cp:lastModifiedBy>pamela zuñiga contreras</cp:lastModifiedBy>
  <cp:revision>1</cp:revision>
  <dcterms:created xsi:type="dcterms:W3CDTF">2022-08-26T23:51:06Z</dcterms:created>
  <dcterms:modified xsi:type="dcterms:W3CDTF">2022-08-26T23:51:45Z</dcterms:modified>
</cp:coreProperties>
</file>